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E03E3"/>
    <a:srgbClr val="3E03E3"/>
    <a:srgbClr val="3403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679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8009D-3915-CBE9-50D7-9669FC1F96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ECE34A9-1796-EC53-852F-A4C345BB8F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7F5DD4-46C5-FFAD-5F71-51917C6C7A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0E1F06-636B-6AF0-E9C7-A3BE8CFCB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F1D07B-EB47-7A71-2E48-5473F7725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112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B8D640-1E04-B331-D55C-701F66802A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B64276-A8C4-2D07-C89E-3B36445381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5774BF-3C33-1FB2-D4C1-3C57E2BD7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B5D633-4F68-22D8-058E-D70BB4818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6FAF63-01A0-9008-AF4D-D92F7AFA4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86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F2C53B-4DF2-ABB7-94A5-8655BDA6AF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2FEE1E-B574-0035-9ED4-F7BF9001FA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F8A3DA-7EEB-EDB7-975E-71140B788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A79A54-33C2-829A-6C8D-AAFA1AFE2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3CDD5D-DEC0-9CC0-3691-1FEF07F28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467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201D14-07A2-1EFE-AE94-D66A571C75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196218-9DE6-540B-B985-5F786334C2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746ED4-57B7-2508-3162-89A17B8BF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61FAC0-8433-271D-655F-19429B61F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4B2D74-9246-4BD3-6D3B-A7D615AAB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690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622D1-0F16-6C3C-E5C6-162B44F93E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3ED037-621C-B85F-B5F1-E63132F92F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5CA3A1-4E54-F7EE-7515-E37FF6E74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7DC999-5651-120A-F247-B555BAB15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E5FAB6-0B50-18F7-34DF-42E8F8E12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174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9E5BE-FA80-501B-72C7-DAC456EB80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3D61A6-AB06-5962-27AA-AABC9754D8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EA02DC-A034-211E-3FD2-5F07123CF7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D1A562-B509-02A0-929B-3D9BD727E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398A79-9A54-83ED-7144-A6F889FBA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51CC58-2F37-23A1-39D9-DCDA64E18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795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F4E38F-DC66-19E6-67BA-B3DADAFF10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51D3DA-7CEB-4BF9-0690-32B5F42448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A3F48B-429A-A025-AD10-91413E2CFC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B55CE6-5A1A-3E69-6801-CAD25315D1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65E41A-D810-D9C4-44C9-B1A10F20A6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27B31D-33B3-7736-95E3-819A7EE75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868A71-FF48-59D5-0264-ECB603F29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6DBB53-7C41-A3ED-EE1F-8F973E193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004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DDEA7-7D06-F575-3C65-141D7CB7CD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B41EFAA-4E1C-28A9-4FDB-0D1F0B296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A326AF-0E9B-200B-8470-634D25F39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1637DB-DAFC-2234-BFE8-D3D933EEB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736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499DFF-3F69-9DDA-B31F-2CEF5AE68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74E3AF-D9B0-02A3-0BB5-A6F2BE075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F00D70-AE6D-6F21-67AB-B8528BCA3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875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59B5E2-7D3A-2295-6158-54C84B654D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6D9374-2164-8501-BB93-0237358842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E2C3B3-1EC4-286A-ECDD-EA1328645F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1AFC59-2F91-7C6F-EBEC-45BAA0241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8793A8-215B-6F7D-C090-4258E92F6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DFBFD4-CC99-458B-68F9-B9FDA0B12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595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69860-D233-8927-627D-F9146B761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5B67AE-9AC5-8FD2-3E6C-88478F4569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6E9BAC-2BAC-3CCA-CB06-2111278343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16F4CE-BADA-607D-D533-BFED3FAFB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91B852-EE3B-649F-DAA2-FD213A29E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B3BB61-B78C-BEA7-4E88-656392E3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567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5B040E-451E-53C6-490B-4506C716B1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A7614D-00FB-70A8-EC7E-BD22234309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760022-817A-32E9-2244-213F4478B3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27F2D-8514-43E5-8EB4-3C3BD8A326E9}" type="datetimeFigureOut">
              <a:rPr lang="en-US" smtClean="0"/>
              <a:t>6/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C50F72-CA33-02CF-74BB-4ECD11E14B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451758-89FB-D943-BEC3-19CBEF1801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061CA-449B-42D8-B802-C8DDA66524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5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BFEFB0E-61BB-2B7E-3D1D-E5ADEE56B8D4}"/>
              </a:ext>
            </a:extLst>
          </p:cNvPr>
          <p:cNvSpPr txBox="1"/>
          <p:nvPr/>
        </p:nvSpPr>
        <p:spPr>
          <a:xfrm>
            <a:off x="1511929" y="4734962"/>
            <a:ext cx="927980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: Cell viability assay by MTT in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hGLC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(A) and in mLTC1 (B). </a:t>
            </a:r>
            <a:r>
              <a:rPr lang="en-GB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cells were treated with 1fM, 1pM, 1nM, 1µM and 1mM of BPA and incubated for 12 hrs, 24 hrs and 48 hrs at 37 °C and 5% CO</a:t>
            </a:r>
            <a:r>
              <a:rPr lang="en-GB" sz="14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GB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hereafter, cells were washed in DPBS and treated with MTT (1mg/mL) solution. After 3 hrs of incubation, MTT solution was removed, and isopropanol (100µL/well) was added to solubilize the formazan crystals. The absorbance was measured at 565 nm.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Data is represented a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. N=3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CD28244-74BF-C4C4-5FFD-0F8C291A49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5031" y="1702599"/>
            <a:ext cx="5612892" cy="28117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82360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80DCED8-4DD7-BE19-70DE-F80B5DBC4119}"/>
              </a:ext>
            </a:extLst>
          </p:cNvPr>
          <p:cNvSpPr txBox="1"/>
          <p:nvPr/>
        </p:nvSpPr>
        <p:spPr>
          <a:xfrm>
            <a:off x="2248277" y="4970352"/>
            <a:ext cx="769544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: The effect of cAMP accumulation in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hGLC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(A) and in mLTC1 (B) by the direct activation of adenylate cyclase activity by Forskolin (50µM) in the presence of BPA at 1nM and 1µM concentrations. Data is represented as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. N=5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C7A5AD7-B116-4C2F-0417-BB75ECF6E3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0781" y="2287021"/>
            <a:ext cx="5708904" cy="2453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6597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0</TotalTime>
  <Words>175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ena</dc:creator>
  <cp:lastModifiedBy>MDPI</cp:lastModifiedBy>
  <cp:revision>11</cp:revision>
  <dcterms:created xsi:type="dcterms:W3CDTF">2023-05-16T06:31:03Z</dcterms:created>
  <dcterms:modified xsi:type="dcterms:W3CDTF">2023-06-02T12:56:48Z</dcterms:modified>
</cp:coreProperties>
</file>